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50" d="100"/>
          <a:sy n="150" d="100"/>
        </p:scale>
        <p:origin x="10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660296E-6BCB-D521-3C31-7FE101197A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C53BA187-AD66-E5F6-DB87-66FAB7EFEF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06A995A-A4C0-67E3-1415-4426064D2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F866D-D05B-4E38-98FA-3B76C0F93E8A}" type="datetimeFigureOut">
              <a:rPr lang="de-DE" smtClean="0"/>
              <a:t>25.03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08E1292-2E19-5DAF-4DB4-2AA4D848F3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FC29E6C-7756-3D10-564B-D1F7B27B5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C99-3B3B-4130-BADF-475102B284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89272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888A980-2CC4-45D5-60AF-CE8D5A0164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6E2E1BF-2DC3-CB4C-A76B-A26F0AE8F3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9FAF1EB-E743-60B8-5941-5892C3D008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F866D-D05B-4E38-98FA-3B76C0F93E8A}" type="datetimeFigureOut">
              <a:rPr lang="de-DE" smtClean="0"/>
              <a:t>25.03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A17D689-D95D-BEC7-A180-FB6A64ECDD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725E9FA-4DE5-0007-AD89-553CB769E2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C99-3B3B-4130-BADF-475102B284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3796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8BAD6240-B57A-12A1-0972-A2F03EA27EB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C3625F46-9ABF-713A-DEDB-7C96660FA3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B7061F1-013F-6995-FDC3-32D5FD855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F866D-D05B-4E38-98FA-3B76C0F93E8A}" type="datetimeFigureOut">
              <a:rPr lang="de-DE" smtClean="0"/>
              <a:t>25.03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883A893-F412-6240-F3C2-61567CD535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A7B2E71-A307-8349-6CB0-7A0DA12999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C99-3B3B-4130-BADF-475102B284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179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4B0CA75-BF11-4943-E1F9-91575FF83E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D682355-CB0D-754C-E236-27CA46F968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BDE573F-4012-E5EF-37BD-689E10D09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F866D-D05B-4E38-98FA-3B76C0F93E8A}" type="datetimeFigureOut">
              <a:rPr lang="de-DE" smtClean="0"/>
              <a:t>25.03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0B899EC-36D4-D39C-323E-BBA3A05490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27D5634-35C0-7B83-C686-201EAAD96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C99-3B3B-4130-BADF-475102B284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8239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EAF40EC-8B08-4874-8269-3B7CDA6C7D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FE6C789-9AA8-8759-63E8-5D828DC354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EEA4A20-9A63-7EF4-EF66-765E4AFD82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F866D-D05B-4E38-98FA-3B76C0F93E8A}" type="datetimeFigureOut">
              <a:rPr lang="de-DE" smtClean="0"/>
              <a:t>25.03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12B6E91-283D-25EE-F47E-5DFB31BEB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2CC0E70-5DF3-6D20-D29C-73501CDBF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C99-3B3B-4130-BADF-475102B284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935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2AC6C2F-FE77-A5E6-125C-78914863A0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ADE3893-64BA-94E1-9799-BEC7473940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79FCD19-C51F-8D6E-E169-FC02DCCF7A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38DD18B-30F0-5F48-9974-48945C2669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F866D-D05B-4E38-98FA-3B76C0F93E8A}" type="datetimeFigureOut">
              <a:rPr lang="de-DE" smtClean="0"/>
              <a:t>25.03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1FE5070-29C8-6A4E-B7D1-49CC0AA023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E75847C-3CF9-0F4A-B8D0-58B45A6CE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C99-3B3B-4130-BADF-475102B284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3268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475723E-F672-2DC4-3639-57360EF616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B2C27C4-CB42-D07D-CBA1-486AEA2FB4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3F608A3B-BAAE-64EE-E5F0-B05BED4D51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9074D512-1AEE-64F3-0573-F7DE19E362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B3750E84-B605-D7B7-C46E-FA297D7607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270324C5-110D-010B-0D06-015735357B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F866D-D05B-4E38-98FA-3B76C0F93E8A}" type="datetimeFigureOut">
              <a:rPr lang="de-DE" smtClean="0"/>
              <a:t>25.03.2026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39F49126-F865-44AB-1ADE-80E4ADC2C3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102887F-55AD-FC5B-0513-DD88C8A423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C99-3B3B-4130-BADF-475102B284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7693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23965F2-DBF5-EF13-851E-D628B03977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082A821D-AF34-F65A-E41A-C6DA23DBBB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F866D-D05B-4E38-98FA-3B76C0F93E8A}" type="datetimeFigureOut">
              <a:rPr lang="de-DE" smtClean="0"/>
              <a:t>25.03.20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E789558-3032-0ABE-82E3-BEC9B55E86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8EDEED17-8FD9-C70B-B580-D2A711C72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C99-3B3B-4130-BADF-475102B284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8773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99420D79-8E8D-EA2A-7EDE-9869A3322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F866D-D05B-4E38-98FA-3B76C0F93E8A}" type="datetimeFigureOut">
              <a:rPr lang="de-DE" smtClean="0"/>
              <a:t>25.03.2026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1C1BF07F-5742-F36D-5E2A-E719E266B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4C316A81-ED8C-9B5D-6F6A-F2CF075FE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C99-3B3B-4130-BADF-475102B284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0168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0B202F8-0977-035B-ADA7-5B3D813403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9E58079-10FF-B442-4A81-6328BE50A96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D20A99E-0A1D-8E21-3643-6E967F5A13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F2DCAB8-110D-3F41-6B95-66F14339DA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F866D-D05B-4E38-98FA-3B76C0F93E8A}" type="datetimeFigureOut">
              <a:rPr lang="de-DE" smtClean="0"/>
              <a:t>25.03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050998E-9A8A-9E55-E594-494894E2C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36AF63A-9E16-2AD6-3192-5B01C706E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C99-3B3B-4130-BADF-475102B284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66503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68F42E7-56C2-AABD-1041-3CDAFAEF96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A9417DBF-7E35-A829-03AF-F947025BEA3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5C17ECB-AD68-DA5A-6EA8-E70E00C53A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8D979E7-243F-CE02-B3F0-08A3D5FA44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F866D-D05B-4E38-98FA-3B76C0F93E8A}" type="datetimeFigureOut">
              <a:rPr lang="de-DE" smtClean="0"/>
              <a:t>25.03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96D44DC-D61A-804F-6A35-30B0A7842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3FC44C7-A10F-4B86-53A6-CD403F311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C99-3B3B-4130-BADF-475102B284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27932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595CE156-C679-C29A-239A-09B83DF606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BE5AD70-9935-E9BB-AD97-D67959A588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28E4817-A95B-478C-ACF1-29994DFBFA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5F866D-D05B-4E38-98FA-3B76C0F93E8A}" type="datetimeFigureOut">
              <a:rPr lang="de-DE" smtClean="0"/>
              <a:t>25.03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62CA378-4445-20E2-5499-5411042331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989C597-29BF-7C98-6557-AB46A8565A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77D1C99-3B3B-4130-BADF-475102B284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737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 descr="Ein Bild, das Gerät, Küchengerät, Haushaltsgerät, Großes Haushaltsgerät enthält.&#10;&#10;KI-generierte Inhalte können fehlerhaft sein.">
            <a:extLst>
              <a:ext uri="{FF2B5EF4-FFF2-40B4-BE49-F238E27FC236}">
                <a16:creationId xmlns:a16="http://schemas.microsoft.com/office/drawing/2014/main" id="{7AC5EC27-8CF8-7D58-0B0D-F8D2DDA3615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6689"/>
          <a:stretch/>
        </p:blipFill>
        <p:spPr>
          <a:xfrm>
            <a:off x="1275365" y="825639"/>
            <a:ext cx="3014505" cy="965061"/>
          </a:xfrm>
          <a:prstGeom prst="rect">
            <a:avLst/>
          </a:prstGeom>
        </p:spPr>
      </p:pic>
      <p:pic>
        <p:nvPicPr>
          <p:cNvPr id="9" name="Grafik 8" descr="Ein Bild, das Text, Screenshot, Gerät enthält.&#10;&#10;KI-generierte Inhalte können fehlerhaft sein.">
            <a:extLst>
              <a:ext uri="{FF2B5EF4-FFF2-40B4-BE49-F238E27FC236}">
                <a16:creationId xmlns:a16="http://schemas.microsoft.com/office/drawing/2014/main" id="{6B136617-6733-7AC0-DEB6-2353F03D92A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5368"/>
          <a:stretch/>
        </p:blipFill>
        <p:spPr>
          <a:xfrm>
            <a:off x="1275364" y="2095639"/>
            <a:ext cx="3014505" cy="1847711"/>
          </a:xfrm>
          <a:prstGeom prst="rect">
            <a:avLst/>
          </a:prstGeom>
        </p:spPr>
      </p:pic>
      <p:sp>
        <p:nvSpPr>
          <p:cNvPr id="10" name="Textfeld 9">
            <a:extLst>
              <a:ext uri="{FF2B5EF4-FFF2-40B4-BE49-F238E27FC236}">
                <a16:creationId xmlns:a16="http://schemas.microsoft.com/office/drawing/2014/main" id="{F5E1B529-C3D9-2240-D256-E3D8240CF187}"/>
              </a:ext>
            </a:extLst>
          </p:cNvPr>
          <p:cNvSpPr txBox="1"/>
          <p:nvPr/>
        </p:nvSpPr>
        <p:spPr>
          <a:xfrm>
            <a:off x="4349750" y="2305050"/>
            <a:ext cx="3219984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Technology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roduc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D#2118)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C479EED7-2DA4-9F1D-104F-34D4A417FA16}"/>
              </a:ext>
            </a:extLst>
          </p:cNvPr>
          <p:cNvSpPr txBox="1"/>
          <p:nvPr/>
        </p:nvSpPr>
        <p:spPr>
          <a:xfrm>
            <a:off x="4289869" y="1123503"/>
            <a:ext cx="290451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Meprin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Custom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generat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Pineda)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D194961D-4E3E-1229-3436-0B53E1F42B0D}"/>
              </a:ext>
            </a:extLst>
          </p:cNvPr>
          <p:cNvSpPr txBox="1"/>
          <p:nvPr/>
        </p:nvSpPr>
        <p:spPr>
          <a:xfrm rot="16200000">
            <a:off x="-804782" y="1973885"/>
            <a:ext cx="35173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ageRuler</a:t>
            </a:r>
            <a:r>
              <a:rPr lang="de-DE" sz="16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r>
              <a:rPr lang="de-DE" sz="1600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Plus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restained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10 – 250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99DF129E-D6FE-B5D8-5B3A-747C0429E802}"/>
              </a:ext>
            </a:extLst>
          </p:cNvPr>
          <p:cNvSpPr txBox="1"/>
          <p:nvPr/>
        </p:nvSpPr>
        <p:spPr>
          <a:xfrm>
            <a:off x="1215483" y="126622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Fig. S2B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5096506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Breitbild</PresentationFormat>
  <Paragraphs>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</vt:lpstr>
      <vt:lpstr>PowerPoint-Präsentation</vt:lpstr>
    </vt:vector>
  </TitlesOfParts>
  <Company>CAU Kie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hn, Dr. Sascha</dc:creator>
  <cp:lastModifiedBy>Rahn, Dr. Sascha</cp:lastModifiedBy>
  <cp:revision>2</cp:revision>
  <dcterms:created xsi:type="dcterms:W3CDTF">2026-03-25T08:12:14Z</dcterms:created>
  <dcterms:modified xsi:type="dcterms:W3CDTF">2026-03-25T08:13:17Z</dcterms:modified>
</cp:coreProperties>
</file>